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16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FAC0D9-DA85-4CE0-B984-FDFB1773AB9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F79597-4A96-421C-8E9D-0E7EF23ABA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6197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F79597-4A96-421C-8E9D-0E7EF23ABAA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9659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0851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220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687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132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6518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5037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8077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8169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78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853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9746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148B39-CF20-415B-BD79-24A7A09BF7C3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3D768D-12C7-452F-98A8-C8547F806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9242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B819DFE9-45D3-F965-F1AE-329B2D5AA57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0984"/>
          <a:stretch/>
        </p:blipFill>
        <p:spPr>
          <a:xfrm>
            <a:off x="0" y="714246"/>
            <a:ext cx="8534400" cy="5061829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9A91BF5B-638A-2B30-6818-FBF48C40FC5D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753927" y="5490593"/>
            <a:ext cx="180000" cy="18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B6CDC216-7183-A048-CC63-1422BE3FAB78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754547" y="5743139"/>
            <a:ext cx="180000" cy="181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16DF8DEE-2995-3CF1-CE1A-D8BE399BCE44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5753986" y="5996685"/>
            <a:ext cx="180000" cy="180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95E579E3-8922-0FDD-90D1-6A87B7716D62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5746644" y="6249231"/>
            <a:ext cx="180000" cy="181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D3578C73-62EE-75A9-1B14-F578149204E3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5746644" y="6498146"/>
            <a:ext cx="180000" cy="18000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982D77F-8D73-A8C5-BF3A-673CEC7BC3EF}"/>
              </a:ext>
            </a:extLst>
          </p:cNvPr>
          <p:cNvSpPr txBox="1"/>
          <p:nvPr/>
        </p:nvSpPr>
        <p:spPr>
          <a:xfrm>
            <a:off x="5925671" y="5434237"/>
            <a:ext cx="3549314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Considerable financial hardship</a:t>
            </a:r>
            <a:r>
              <a:rPr lang="en-US" altLang="ja-JP" sz="1600" dirty="0"/>
              <a:t> </a:t>
            </a:r>
            <a:endParaRPr kumimoji="1" lang="ja-JP" altLang="en-US" sz="1600" dirty="0"/>
          </a:p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Mild financial hardship</a:t>
            </a:r>
            <a:endParaRPr lang="en-US" altLang="ja-JP" sz="1600" dirty="0"/>
          </a:p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Average financial security</a:t>
            </a:r>
            <a:endParaRPr lang="en-US" altLang="ja-JP" sz="1600" dirty="0"/>
          </a:p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Moderate financial security</a:t>
            </a:r>
            <a:endParaRPr lang="en-US" altLang="ja-JP" sz="1600" dirty="0"/>
          </a:p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High financial security</a:t>
            </a:r>
            <a:endParaRPr lang="en-US" altLang="ja-JP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6808611-AB92-AB83-7806-F378F76D33EC}"/>
              </a:ext>
            </a:extLst>
          </p:cNvPr>
          <p:cNvSpPr txBox="1"/>
          <p:nvPr/>
        </p:nvSpPr>
        <p:spPr>
          <a:xfrm>
            <a:off x="0" y="0"/>
            <a:ext cx="9144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Arial" panose="020B0604020202020204" pitchFamily="34" charset="0"/>
              </a:rPr>
              <a:t>Supplemental material 3-1.</a:t>
            </a:r>
          </a:p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Arial" panose="020B0604020202020204" pitchFamily="34" charset="0"/>
              </a:rPr>
              <a:t>Subjective financial hardship by time since diagnosis among patients with brain tumors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89951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2B2E8C5C-9F5A-7BFA-4A16-EACB5AAB29D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0405"/>
          <a:stretch/>
        </p:blipFill>
        <p:spPr>
          <a:xfrm>
            <a:off x="0" y="681315"/>
            <a:ext cx="8534400" cy="509476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C57398D-4F99-0AC8-1355-EC24E9202909}"/>
              </a:ext>
            </a:extLst>
          </p:cNvPr>
          <p:cNvSpPr txBox="1"/>
          <p:nvPr/>
        </p:nvSpPr>
        <p:spPr>
          <a:xfrm>
            <a:off x="5925671" y="5434237"/>
            <a:ext cx="3549314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Considerable financial hardship</a:t>
            </a:r>
            <a:r>
              <a:rPr lang="en-US" altLang="ja-JP" sz="1600" dirty="0"/>
              <a:t> </a:t>
            </a:r>
            <a:endParaRPr kumimoji="1" lang="ja-JP" altLang="en-US" sz="1600" dirty="0"/>
          </a:p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Mild financial hardship</a:t>
            </a:r>
            <a:endParaRPr lang="en-US" altLang="ja-JP" sz="1600" dirty="0"/>
          </a:p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Average financial security</a:t>
            </a:r>
            <a:endParaRPr lang="en-US" altLang="ja-JP" sz="1600" dirty="0"/>
          </a:p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Moderate financial security</a:t>
            </a:r>
            <a:endParaRPr lang="en-US" altLang="ja-JP" sz="1600" dirty="0"/>
          </a:p>
          <a:p>
            <a:r>
              <a:rPr lang="en-US" altLang="ja-JP" sz="1600" b="0" i="0" u="none" strike="noStrike" dirty="0">
                <a:solidFill>
                  <a:srgbClr val="000000"/>
                </a:solidFill>
                <a:effectLst/>
                <a:latin typeface="Yu Gothic" panose="020B0400000000000000" pitchFamily="50" charset="-128"/>
                <a:ea typeface="Yu Gothic" panose="020B0400000000000000" pitchFamily="50" charset="-128"/>
              </a:rPr>
              <a:t>High financial security</a:t>
            </a:r>
            <a:endParaRPr lang="en-US" altLang="ja-JP" sz="1600" dirty="0"/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BDC6F307-3F7D-A4E3-8DFA-DFC7432DCEA7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753927" y="5490593"/>
            <a:ext cx="180000" cy="180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1ED858B1-567C-013D-DD5E-F839177B8328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754547" y="5743139"/>
            <a:ext cx="180000" cy="181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D44E3927-FC79-1A30-06C4-A9C5BCA9C2CA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753986" y="5996685"/>
            <a:ext cx="180000" cy="18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9A1D4EDC-AE6B-DA11-C476-B9D5396ABA7D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5746644" y="6249231"/>
            <a:ext cx="180000" cy="18100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833D1D1D-EAF4-7F59-3250-07B48905896C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5746644" y="6498146"/>
            <a:ext cx="180000" cy="180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329BE2D-380C-31D2-D390-493B6C708B6B}"/>
              </a:ext>
            </a:extLst>
          </p:cNvPr>
          <p:cNvSpPr txBox="1"/>
          <p:nvPr/>
        </p:nvSpPr>
        <p:spPr>
          <a:xfrm>
            <a:off x="0" y="0"/>
            <a:ext cx="9144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Arial" panose="020B0604020202020204" pitchFamily="34" charset="0"/>
              </a:rPr>
              <a:t>Supplemental material 3-2.</a:t>
            </a:r>
          </a:p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Arial" panose="020B0604020202020204" pitchFamily="34" charset="0"/>
              </a:rPr>
              <a:t>Subjective financial hardship by time since diagnosis among family members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01580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61</Words>
  <Application>Microsoft Office PowerPoint</Application>
  <PresentationFormat>画面に合わせる (4:3)</PresentationFormat>
  <Paragraphs>15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ゴシック</vt:lpstr>
      <vt:lpstr>游明朝</vt:lpstr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to Iori</dc:creator>
  <cp:lastModifiedBy>Sato Iori</cp:lastModifiedBy>
  <cp:revision>2</cp:revision>
  <dcterms:created xsi:type="dcterms:W3CDTF">2025-03-24T02:27:23Z</dcterms:created>
  <dcterms:modified xsi:type="dcterms:W3CDTF">2025-03-25T01:01:11Z</dcterms:modified>
</cp:coreProperties>
</file>